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8F8C540-65D7-4D39-8E06-3E25BE8966A3}" v="1" dt="2024-05-31T10:17:47.6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68" d="100"/>
          <a:sy n="68" d="100"/>
        </p:scale>
        <p:origin x="173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58F8C540-65D7-4D39-8E06-3E25BE8966A3}"/>
    <pc:docChg chg="undo custSel delSld modSld">
      <pc:chgData name="Laycock, Joseph" userId="c4bfcbf4-3ccc-440e-b317-559baf184f0d" providerId="ADAL" clId="{58F8C540-65D7-4D39-8E06-3E25BE8966A3}" dt="2024-05-31T10:20:10.820" v="73" actId="1036"/>
      <pc:docMkLst>
        <pc:docMk/>
      </pc:docMkLst>
      <pc:sldChg chg="addSp delSp modSp mod">
        <pc:chgData name="Laycock, Joseph" userId="c4bfcbf4-3ccc-440e-b317-559baf184f0d" providerId="ADAL" clId="{58F8C540-65D7-4D39-8E06-3E25BE8966A3}" dt="2024-05-31T10:20:10.820" v="73" actId="1036"/>
        <pc:sldMkLst>
          <pc:docMk/>
          <pc:sldMk cId="2867428870" sldId="268"/>
        </pc:sldMkLst>
        <pc:spChg chg="del">
          <ac:chgData name="Laycock, Joseph" userId="c4bfcbf4-3ccc-440e-b317-559baf184f0d" providerId="ADAL" clId="{58F8C540-65D7-4D39-8E06-3E25BE8966A3}" dt="2024-05-31T10:17:46.481" v="37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58F8C540-65D7-4D39-8E06-3E25BE8966A3}" dt="2024-05-31T10:17:47.670" v="38"/>
          <ac:spMkLst>
            <pc:docMk/>
            <pc:sldMk cId="2867428870" sldId="268"/>
            <ac:spMk id="3" creationId="{59ED726F-4BAC-D42B-74C4-B55EFDCC5F38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4" creationId="{C7299699-DD11-0467-93F5-FFA4F1A3821A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5" creationId="{25D811B4-AB23-8C94-B091-0F0772B52EA2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8" creationId="{61024EA4-D201-0182-D863-AFA3B380CCCF}"/>
          </ac:spMkLst>
        </pc:spChg>
        <pc:spChg chg="add mod">
          <ac:chgData name="Laycock, Joseph" userId="c4bfcbf4-3ccc-440e-b317-559baf184f0d" providerId="ADAL" clId="{58F8C540-65D7-4D39-8E06-3E25BE8966A3}" dt="2024-05-31T10:20:10.820" v="73" actId="1036"/>
          <ac:spMkLst>
            <pc:docMk/>
            <pc:sldMk cId="2867428870" sldId="268"/>
            <ac:spMk id="9" creationId="{EF592A03-462C-391F-9868-F3633700B1C0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10" creationId="{46944760-3BA4-2CA8-50A1-AA31DEFF00DA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11" creationId="{68D2AFA7-237F-0B97-DA71-3B8DB15B19C0}"/>
          </ac:spMkLst>
        </pc:spChg>
        <pc:spChg chg="add mod">
          <ac:chgData name="Laycock, Joseph" userId="c4bfcbf4-3ccc-440e-b317-559baf184f0d" providerId="ADAL" clId="{58F8C540-65D7-4D39-8E06-3E25BE8966A3}" dt="2024-05-31T10:17:47.670" v="38"/>
          <ac:spMkLst>
            <pc:docMk/>
            <pc:sldMk cId="2867428870" sldId="268"/>
            <ac:spMk id="12" creationId="{141B2777-747A-A7F0-A887-063945758A30}"/>
          </ac:spMkLst>
        </pc:spChg>
        <pc:spChg chg="add mod">
          <ac:chgData name="Laycock, Joseph" userId="c4bfcbf4-3ccc-440e-b317-559baf184f0d" providerId="ADAL" clId="{58F8C540-65D7-4D39-8E06-3E25BE8966A3}" dt="2024-05-31T10:17:47.670" v="38"/>
          <ac:spMkLst>
            <pc:docMk/>
            <pc:sldMk cId="2867428870" sldId="268"/>
            <ac:spMk id="13" creationId="{C744E8A6-028D-F076-991F-652F9B155516}"/>
          </ac:spMkLst>
        </pc:spChg>
        <pc:spChg chg="add mod">
          <ac:chgData name="Laycock, Joseph" userId="c4bfcbf4-3ccc-440e-b317-559baf184f0d" providerId="ADAL" clId="{58F8C540-65D7-4D39-8E06-3E25BE8966A3}" dt="2024-05-31T10:17:47.670" v="38"/>
          <ac:spMkLst>
            <pc:docMk/>
            <pc:sldMk cId="2867428870" sldId="268"/>
            <ac:spMk id="14" creationId="{6BEE4DAA-E62B-01F2-9191-CBA98204C62E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17" creationId="{EFD4864C-ACE6-C450-E1F9-940FAD18183D}"/>
          </ac:spMkLst>
        </pc:spChg>
        <pc:spChg chg="add mod">
          <ac:chgData name="Laycock, Joseph" userId="c4bfcbf4-3ccc-440e-b317-559baf184f0d" providerId="ADAL" clId="{58F8C540-65D7-4D39-8E06-3E25BE8966A3}" dt="2024-05-31T10:19:54.530" v="69" actId="1036"/>
          <ac:spMkLst>
            <pc:docMk/>
            <pc:sldMk cId="2867428870" sldId="268"/>
            <ac:spMk id="18" creationId="{21E20FD4-3CCE-1B35-D8BD-C9B606AB0755}"/>
          </ac:spMkLst>
        </pc:spChg>
        <pc:spChg chg="mod">
          <ac:chgData name="Laycock, Joseph" userId="c4bfcbf4-3ccc-440e-b317-559baf184f0d" providerId="ADAL" clId="{58F8C540-65D7-4D39-8E06-3E25BE8966A3}" dt="2024-05-31T10:16:38.664" v="9" actId="20577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58F8C540-65D7-4D39-8E06-3E25BE8966A3}" dt="2024-05-31T10:18:43.240" v="47" actId="1036"/>
          <ac:spMkLst>
            <pc:docMk/>
            <pc:sldMk cId="2867428870" sldId="268"/>
            <ac:spMk id="25" creationId="{00000000-0000-0000-0000-000000000000}"/>
          </ac:spMkLst>
        </pc:spChg>
        <pc:spChg chg="del">
          <ac:chgData name="Laycock, Joseph" userId="c4bfcbf4-3ccc-440e-b317-559baf184f0d" providerId="ADAL" clId="{58F8C540-65D7-4D39-8E06-3E25BE8966A3}" dt="2024-05-31T10:17:46.481" v="37" actId="478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58F8C540-65D7-4D39-8E06-3E25BE8966A3}" dt="2024-05-31T10:17:26.060" v="36" actId="20577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58F8C540-65D7-4D39-8E06-3E25BE8966A3}" dt="2024-05-31T10:17:17.745" v="31"/>
          <ac:spMkLst>
            <pc:docMk/>
            <pc:sldMk cId="2867428870" sldId="268"/>
            <ac:spMk id="28" creationId="{00000000-0000-0000-0000-000000000000}"/>
          </ac:spMkLst>
        </pc:spChg>
        <pc:cxnChg chg="add mod">
          <ac:chgData name="Laycock, Joseph" userId="c4bfcbf4-3ccc-440e-b317-559baf184f0d" providerId="ADAL" clId="{58F8C540-65D7-4D39-8E06-3E25BE8966A3}" dt="2024-05-31T10:19:54.530" v="69" actId="1036"/>
          <ac:cxnSpMkLst>
            <pc:docMk/>
            <pc:sldMk cId="2867428870" sldId="268"/>
            <ac:cxnSpMk id="6" creationId="{075D3687-18BB-1D9A-CEC7-AA3559A49BE5}"/>
          </ac:cxnSpMkLst>
        </pc:cxnChg>
        <pc:cxnChg chg="add mod">
          <ac:chgData name="Laycock, Joseph" userId="c4bfcbf4-3ccc-440e-b317-559baf184f0d" providerId="ADAL" clId="{58F8C540-65D7-4D39-8E06-3E25BE8966A3}" dt="2024-05-31T10:19:54.530" v="69" actId="1036"/>
          <ac:cxnSpMkLst>
            <pc:docMk/>
            <pc:sldMk cId="2867428870" sldId="268"/>
            <ac:cxnSpMk id="7" creationId="{61D747A1-FDEF-AD77-60BF-9FCB2C01C1D7}"/>
          </ac:cxnSpMkLst>
        </pc:cxnChg>
        <pc:cxnChg chg="add mod">
          <ac:chgData name="Laycock, Joseph" userId="c4bfcbf4-3ccc-440e-b317-559baf184f0d" providerId="ADAL" clId="{58F8C540-65D7-4D39-8E06-3E25BE8966A3}" dt="2024-05-31T10:19:54.530" v="69" actId="1036"/>
          <ac:cxnSpMkLst>
            <pc:docMk/>
            <pc:sldMk cId="2867428870" sldId="268"/>
            <ac:cxnSpMk id="15" creationId="{CEB2B783-8B19-5928-56A3-8752F1EC0131}"/>
          </ac:cxnSpMkLst>
        </pc:cxnChg>
        <pc:cxnChg chg="add mod">
          <ac:chgData name="Laycock, Joseph" userId="c4bfcbf4-3ccc-440e-b317-559baf184f0d" providerId="ADAL" clId="{58F8C540-65D7-4D39-8E06-3E25BE8966A3}" dt="2024-05-31T10:19:54.530" v="69" actId="1036"/>
          <ac:cxnSpMkLst>
            <pc:docMk/>
            <pc:sldMk cId="2867428870" sldId="268"/>
            <ac:cxnSpMk id="16" creationId="{B03D23CE-E7BD-0FE4-72F3-34F1DC2C303C}"/>
          </ac:cxnSpMkLst>
        </pc:cxnChg>
      </pc:sldChg>
      <pc:sldChg chg="del">
        <pc:chgData name="Laycock, Joseph" userId="c4bfcbf4-3ccc-440e-b317-559baf184f0d" providerId="ADAL" clId="{58F8C540-65D7-4D39-8E06-3E25BE8966A3}" dt="2024-05-31T10:16:23.585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58F8C540-65D7-4D39-8E06-3E25BE8966A3}" dt="2024-05-31T10:16:25.155" v="1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58F8C540-65D7-4D39-8E06-3E25BE8966A3}" dt="2024-05-31T10:16:25.615" v="2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58F8C540-65D7-4D39-8E06-3E25BE8966A3}" dt="2024-05-31T10:16:27.241" v="5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58F8C540-65D7-4D39-8E06-3E25BE8966A3}" dt="2024-05-31T10:16:26.450" v="4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58F8C540-65D7-4D39-8E06-3E25BE8966A3}" dt="2024-05-31T10:16:26.112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58F8C540-65D7-4D39-8E06-3E25BE8966A3}" dt="2024-05-31T10:16:25.615" v="2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58F8C540-65D7-4D39-8E06-3E25BE8966A3}" dt="2024-05-31T10:16:25.615" v="2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Pneumococcal carriage and serotype distribution in children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with nephrotic syndrome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36628" y="1099447"/>
            <a:ext cx="11119994" cy="5410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GB" sz="1800" b="1" dirty="0">
                <a:solidFill>
                  <a:schemeClr val="bg1"/>
                </a:solidFill>
              </a:rPr>
              <a:t>AIM:</a:t>
            </a:r>
            <a:r>
              <a:rPr lang="en-GB" sz="1800" dirty="0">
                <a:solidFill>
                  <a:schemeClr val="bg1"/>
                </a:solidFill>
              </a:rPr>
              <a:t> To evaluate the frequency of pneumococcal colonization and the serotype distribution in children with nephrotic syndrome, which is at increased risk for invasive pneumococcal disease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Erem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  <a:effectLst/>
                <a:ea typeface="Times New Roman" panose="02020603050405020304" pitchFamily="18" charset="0"/>
              </a:rPr>
              <a:t>While the pneumococcal carriage rate was similar between children with NS and healthy children, children with NS have an increased risk for IPD and </a:t>
            </a:r>
            <a:r>
              <a:rPr lang="en-US" dirty="0">
                <a:solidFill>
                  <a:schemeClr val="bg1"/>
                </a:solidFill>
                <a:ea typeface="Times New Roman" panose="02020603050405020304" pitchFamily="18" charset="0"/>
              </a:rPr>
              <a:t>unvaccinated children are carriers for non-PCV13 serotype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9ED726F-4BAC-D42B-74C4-B55EFDCC5F38}"/>
              </a:ext>
            </a:extLst>
          </p:cNvPr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4" name="Rectangle 19">
            <a:extLst>
              <a:ext uri="{FF2B5EF4-FFF2-40B4-BE49-F238E27FC236}">
                <a16:creationId xmlns:a16="http://schemas.microsoft.com/office/drawing/2014/main" id="{C7299699-DD11-0467-93F5-FFA4F1A3821A}"/>
              </a:ext>
            </a:extLst>
          </p:cNvPr>
          <p:cNvSpPr/>
          <p:nvPr/>
        </p:nvSpPr>
        <p:spPr>
          <a:xfrm>
            <a:off x="236628" y="4220305"/>
            <a:ext cx="1515969" cy="675227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100 matched healthy controls</a:t>
            </a:r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25D811B4-AB23-8C94-B091-0F0772B52EA2}"/>
              </a:ext>
            </a:extLst>
          </p:cNvPr>
          <p:cNvSpPr/>
          <p:nvPr/>
        </p:nvSpPr>
        <p:spPr>
          <a:xfrm>
            <a:off x="236628" y="2675067"/>
            <a:ext cx="1515969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98 children with Nephrotic Syndrome</a:t>
            </a:r>
          </a:p>
        </p:txBody>
      </p:sp>
      <p:cxnSp>
        <p:nvCxnSpPr>
          <p:cNvPr id="6" name="Straight Arrow Connector 13">
            <a:extLst>
              <a:ext uri="{FF2B5EF4-FFF2-40B4-BE49-F238E27FC236}">
                <a16:creationId xmlns:a16="http://schemas.microsoft.com/office/drawing/2014/main" id="{075D3687-18BB-1D9A-CEC7-AA3559A49BE5}"/>
              </a:ext>
            </a:extLst>
          </p:cNvPr>
          <p:cNvCxnSpPr>
            <a:cxnSpLocks/>
          </p:cNvCxnSpPr>
          <p:nvPr/>
        </p:nvCxnSpPr>
        <p:spPr>
          <a:xfrm>
            <a:off x="1752597" y="2982673"/>
            <a:ext cx="1728385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13">
            <a:extLst>
              <a:ext uri="{FF2B5EF4-FFF2-40B4-BE49-F238E27FC236}">
                <a16:creationId xmlns:a16="http://schemas.microsoft.com/office/drawing/2014/main" id="{61D747A1-FDEF-AD77-60BF-9FCB2C01C1D7}"/>
              </a:ext>
            </a:extLst>
          </p:cNvPr>
          <p:cNvCxnSpPr>
            <a:cxnSpLocks/>
          </p:cNvCxnSpPr>
          <p:nvPr/>
        </p:nvCxnSpPr>
        <p:spPr>
          <a:xfrm>
            <a:off x="1752597" y="4513330"/>
            <a:ext cx="1728385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55">
            <a:extLst>
              <a:ext uri="{FF2B5EF4-FFF2-40B4-BE49-F238E27FC236}">
                <a16:creationId xmlns:a16="http://schemas.microsoft.com/office/drawing/2014/main" id="{61024EA4-D201-0182-D863-AFA3B380CCCF}"/>
              </a:ext>
            </a:extLst>
          </p:cNvPr>
          <p:cNvSpPr/>
          <p:nvPr/>
        </p:nvSpPr>
        <p:spPr>
          <a:xfrm>
            <a:off x="3603464" y="3411290"/>
            <a:ext cx="2039053" cy="765624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400" dirty="0"/>
              <a:t>Molecular detection of nasopharyngeal pneumococcal carriage</a:t>
            </a:r>
          </a:p>
        </p:txBody>
      </p:sp>
      <p:sp>
        <p:nvSpPr>
          <p:cNvPr id="9" name="Rectangle 58">
            <a:extLst>
              <a:ext uri="{FF2B5EF4-FFF2-40B4-BE49-F238E27FC236}">
                <a16:creationId xmlns:a16="http://schemas.microsoft.com/office/drawing/2014/main" id="{EF592A03-462C-391F-9868-F3633700B1C0}"/>
              </a:ext>
            </a:extLst>
          </p:cNvPr>
          <p:cNvSpPr/>
          <p:nvPr/>
        </p:nvSpPr>
        <p:spPr>
          <a:xfrm>
            <a:off x="2766951" y="1754104"/>
            <a:ext cx="3657600" cy="451113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PNEUMOCOCCAL CARRIAGE RATE</a:t>
            </a:r>
          </a:p>
        </p:txBody>
      </p:sp>
      <p:sp>
        <p:nvSpPr>
          <p:cNvPr id="10" name="Rectangle 58">
            <a:extLst>
              <a:ext uri="{FF2B5EF4-FFF2-40B4-BE49-F238E27FC236}">
                <a16:creationId xmlns:a16="http://schemas.microsoft.com/office/drawing/2014/main" id="{46944760-3BA4-2CA8-50A1-AA31DEFF00DA}"/>
              </a:ext>
            </a:extLst>
          </p:cNvPr>
          <p:cNvSpPr/>
          <p:nvPr/>
        </p:nvSpPr>
        <p:spPr>
          <a:xfrm>
            <a:off x="3742007" y="2675067"/>
            <a:ext cx="1735313" cy="622841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004277"/>
                </a:solidFill>
              </a:rPr>
              <a:t>44.9%</a:t>
            </a:r>
          </a:p>
        </p:txBody>
      </p:sp>
      <p:sp>
        <p:nvSpPr>
          <p:cNvPr id="11" name="Rectangle 58">
            <a:extLst>
              <a:ext uri="{FF2B5EF4-FFF2-40B4-BE49-F238E27FC236}">
                <a16:creationId xmlns:a16="http://schemas.microsoft.com/office/drawing/2014/main" id="{68D2AFA7-237F-0B97-DA71-3B8DB15B19C0}"/>
              </a:ext>
            </a:extLst>
          </p:cNvPr>
          <p:cNvSpPr/>
          <p:nvPr/>
        </p:nvSpPr>
        <p:spPr>
          <a:xfrm>
            <a:off x="3742006" y="4261136"/>
            <a:ext cx="1735313" cy="622841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004277"/>
                </a:solidFill>
              </a:rPr>
              <a:t>48.0%</a:t>
            </a:r>
          </a:p>
        </p:txBody>
      </p:sp>
      <p:sp>
        <p:nvSpPr>
          <p:cNvPr id="12" name="Rectangle 58">
            <a:extLst>
              <a:ext uri="{FF2B5EF4-FFF2-40B4-BE49-F238E27FC236}">
                <a16:creationId xmlns:a16="http://schemas.microsoft.com/office/drawing/2014/main" id="{141B2777-747A-A7F0-A887-063945758A30}"/>
              </a:ext>
            </a:extLst>
          </p:cNvPr>
          <p:cNvSpPr/>
          <p:nvPr/>
        </p:nvSpPr>
        <p:spPr>
          <a:xfrm>
            <a:off x="7905072" y="1767519"/>
            <a:ext cx="3657600" cy="451113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277"/>
                </a:solidFill>
              </a:rPr>
              <a:t>SEROTYPE DISTRIBUTION</a:t>
            </a:r>
          </a:p>
        </p:txBody>
      </p:sp>
      <p:sp>
        <p:nvSpPr>
          <p:cNvPr id="13" name="Rectangle 58">
            <a:extLst>
              <a:ext uri="{FF2B5EF4-FFF2-40B4-BE49-F238E27FC236}">
                <a16:creationId xmlns:a16="http://schemas.microsoft.com/office/drawing/2014/main" id="{C744E8A6-028D-F076-991F-652F9B155516}"/>
              </a:ext>
            </a:extLst>
          </p:cNvPr>
          <p:cNvSpPr/>
          <p:nvPr/>
        </p:nvSpPr>
        <p:spPr>
          <a:xfrm>
            <a:off x="6805962" y="2447976"/>
            <a:ext cx="5259657" cy="1243419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rotypes 3 and 19F (predominant)</a:t>
            </a:r>
          </a:p>
          <a:p>
            <a:pPr algn="ctr"/>
            <a:r>
              <a:rPr lang="en-US" sz="1400" dirty="0">
                <a:solidFill>
                  <a:schemeClr val="accent1">
                    <a:lumMod val="50000"/>
                  </a:schemeClr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CV13 vaccine serotypes have been detected in 45.8% of PCV-vaccinated children with NS, while those serotypes have been detected in 66.6% of unvaccinated children. </a:t>
            </a:r>
            <a:endParaRPr lang="en-US" sz="1400" b="1" dirty="0">
              <a:solidFill>
                <a:schemeClr val="accent1">
                  <a:lumMod val="50000"/>
                </a:schemeClr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14" name="Rectangle 58">
            <a:extLst>
              <a:ext uri="{FF2B5EF4-FFF2-40B4-BE49-F238E27FC236}">
                <a16:creationId xmlns:a16="http://schemas.microsoft.com/office/drawing/2014/main" id="{6BEE4DAA-E62B-01F2-9191-CBA98204C62E}"/>
              </a:ext>
            </a:extLst>
          </p:cNvPr>
          <p:cNvSpPr/>
          <p:nvPr/>
        </p:nvSpPr>
        <p:spPr>
          <a:xfrm>
            <a:off x="6805962" y="3953173"/>
            <a:ext cx="5259657" cy="1243415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b="1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S</a:t>
            </a:r>
            <a:r>
              <a:rPr lang="en-US" sz="1400" b="1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rotypes 3 and 19F (predominant)</a:t>
            </a:r>
          </a:p>
          <a:p>
            <a:pPr algn="ctr"/>
            <a:r>
              <a:rPr lang="en-US" sz="1400" dirty="0">
                <a:solidFill>
                  <a:srgbClr val="004277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prevalence of pneumococcal carriage was greater in healthy children who did not receive the PCV vaccine compared to those who did receive it (p&lt;0.05). </a:t>
            </a:r>
          </a:p>
        </p:txBody>
      </p:sp>
      <p:cxnSp>
        <p:nvCxnSpPr>
          <p:cNvPr id="15" name="Straight Arrow Connector 13">
            <a:extLst>
              <a:ext uri="{FF2B5EF4-FFF2-40B4-BE49-F238E27FC236}">
                <a16:creationId xmlns:a16="http://schemas.microsoft.com/office/drawing/2014/main" id="{CEB2B783-8B19-5928-56A3-8752F1EC0131}"/>
              </a:ext>
            </a:extLst>
          </p:cNvPr>
          <p:cNvCxnSpPr>
            <a:cxnSpLocks/>
          </p:cNvCxnSpPr>
          <p:nvPr/>
        </p:nvCxnSpPr>
        <p:spPr>
          <a:xfrm>
            <a:off x="5642517" y="3032266"/>
            <a:ext cx="893545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3">
            <a:extLst>
              <a:ext uri="{FF2B5EF4-FFF2-40B4-BE49-F238E27FC236}">
                <a16:creationId xmlns:a16="http://schemas.microsoft.com/office/drawing/2014/main" id="{B03D23CE-E7BD-0FE4-72F3-34F1DC2C303C}"/>
              </a:ext>
            </a:extLst>
          </p:cNvPr>
          <p:cNvCxnSpPr>
            <a:cxnSpLocks/>
          </p:cNvCxnSpPr>
          <p:nvPr/>
        </p:nvCxnSpPr>
        <p:spPr>
          <a:xfrm>
            <a:off x="5642517" y="4543636"/>
            <a:ext cx="893545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32">
            <a:extLst>
              <a:ext uri="{FF2B5EF4-FFF2-40B4-BE49-F238E27FC236}">
                <a16:creationId xmlns:a16="http://schemas.microsoft.com/office/drawing/2014/main" id="{EFD4864C-ACE6-C450-E1F9-940FAD18183D}"/>
              </a:ext>
            </a:extLst>
          </p:cNvPr>
          <p:cNvSpPr txBox="1"/>
          <p:nvPr/>
        </p:nvSpPr>
        <p:spPr>
          <a:xfrm>
            <a:off x="1675842" y="3015639"/>
            <a:ext cx="17624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004277"/>
                </a:solidFill>
              </a:rPr>
              <a:t>Previously at least one dose of PCV13 vaccinated: 73.5%</a:t>
            </a:r>
          </a:p>
        </p:txBody>
      </p:sp>
      <p:sp>
        <p:nvSpPr>
          <p:cNvPr id="18" name="TextBox 32">
            <a:extLst>
              <a:ext uri="{FF2B5EF4-FFF2-40B4-BE49-F238E27FC236}">
                <a16:creationId xmlns:a16="http://schemas.microsoft.com/office/drawing/2014/main" id="{21E20FD4-3CCE-1B35-D8BD-C9B606AB0755}"/>
              </a:ext>
            </a:extLst>
          </p:cNvPr>
          <p:cNvSpPr txBox="1"/>
          <p:nvPr/>
        </p:nvSpPr>
        <p:spPr>
          <a:xfrm>
            <a:off x="1667329" y="4556037"/>
            <a:ext cx="176242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004277"/>
                </a:solidFill>
              </a:rPr>
              <a:t>Previously at least one dose of PCV13 vaccinated: 86.5%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7</TotalTime>
  <Words>20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5-31T10:20:11Z</dcterms:modified>
</cp:coreProperties>
</file>